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3" d="100"/>
          <a:sy n="43" d="100"/>
        </p:scale>
        <p:origin x="54" y="4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CBF94-B5F9-4EC7-8805-15FE4302F2DF}" type="datetimeFigureOut">
              <a:rPr lang="en-GB" smtClean="0"/>
              <a:t>26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13DA-38A6-40A3-AC10-B7C827279C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9551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CBF94-B5F9-4EC7-8805-15FE4302F2DF}" type="datetimeFigureOut">
              <a:rPr lang="en-GB" smtClean="0"/>
              <a:t>26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13DA-38A6-40A3-AC10-B7C827279C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1011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CBF94-B5F9-4EC7-8805-15FE4302F2DF}" type="datetimeFigureOut">
              <a:rPr lang="en-GB" smtClean="0"/>
              <a:t>26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13DA-38A6-40A3-AC10-B7C827279C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6616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CBF94-B5F9-4EC7-8805-15FE4302F2DF}" type="datetimeFigureOut">
              <a:rPr lang="en-GB" smtClean="0"/>
              <a:t>26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13DA-38A6-40A3-AC10-B7C827279C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5889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CBF94-B5F9-4EC7-8805-15FE4302F2DF}" type="datetimeFigureOut">
              <a:rPr lang="en-GB" smtClean="0"/>
              <a:t>26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13DA-38A6-40A3-AC10-B7C827279C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0192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CBF94-B5F9-4EC7-8805-15FE4302F2DF}" type="datetimeFigureOut">
              <a:rPr lang="en-GB" smtClean="0"/>
              <a:t>26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13DA-38A6-40A3-AC10-B7C827279C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5476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CBF94-B5F9-4EC7-8805-15FE4302F2DF}" type="datetimeFigureOut">
              <a:rPr lang="en-GB" smtClean="0"/>
              <a:t>26/0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13DA-38A6-40A3-AC10-B7C827279C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2966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CBF94-B5F9-4EC7-8805-15FE4302F2DF}" type="datetimeFigureOut">
              <a:rPr lang="en-GB" smtClean="0"/>
              <a:t>26/0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13DA-38A6-40A3-AC10-B7C827279C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9372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CBF94-B5F9-4EC7-8805-15FE4302F2DF}" type="datetimeFigureOut">
              <a:rPr lang="en-GB" smtClean="0"/>
              <a:t>26/0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13DA-38A6-40A3-AC10-B7C827279C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8411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CBF94-B5F9-4EC7-8805-15FE4302F2DF}" type="datetimeFigureOut">
              <a:rPr lang="en-GB" smtClean="0"/>
              <a:t>26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13DA-38A6-40A3-AC10-B7C827279C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2069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CBF94-B5F9-4EC7-8805-15FE4302F2DF}" type="datetimeFigureOut">
              <a:rPr lang="en-GB" smtClean="0"/>
              <a:t>26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213DA-38A6-40A3-AC10-B7C827279C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6445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BCBF94-B5F9-4EC7-8805-15FE4302F2DF}" type="datetimeFigureOut">
              <a:rPr lang="en-GB" smtClean="0"/>
              <a:t>26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3213DA-38A6-40A3-AC10-B7C827279C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7212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2298834"/>
              </p:ext>
            </p:extLst>
          </p:nvPr>
        </p:nvGraphicFramePr>
        <p:xfrm>
          <a:off x="679621" y="1295679"/>
          <a:ext cx="10923373" cy="3002280"/>
        </p:xfrm>
        <a:graphic>
          <a:graphicData uri="http://schemas.openxmlformats.org/drawingml/2006/table">
            <a:tbl>
              <a:tblPr/>
              <a:tblGrid>
                <a:gridCol w="2239591"/>
                <a:gridCol w="583495"/>
                <a:gridCol w="798015"/>
                <a:gridCol w="592077"/>
                <a:gridCol w="798015"/>
                <a:gridCol w="2960381"/>
                <a:gridCol w="2951799"/>
              </a:tblGrid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ymptom/Sig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P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P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nsitivity (95% CI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pecificity (95% CI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ncontinence</a:t>
                      </a:r>
                      <a:r>
                        <a:rPr lang="en-GB" sz="2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5</a:t>
                      </a:r>
                      <a:endParaRPr lang="en-GB" sz="2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9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48 (0.33 - 0.63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55 (0.53 - 0.56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ncontinent</a:t>
                      </a:r>
                      <a:r>
                        <a:rPr lang="en-GB" sz="2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4</a:t>
                      </a:r>
                      <a:endParaRPr lang="en-GB" sz="2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9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80 (0.61 - 0.9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19 (0.18 - 0.2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isoriented</a:t>
                      </a:r>
                      <a:r>
                        <a:rPr lang="en-GB" sz="2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4</a:t>
                      </a:r>
                      <a:endParaRPr lang="en-GB" sz="2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44 (0.27 - 0.63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41 (0.39 - 0.42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Wounds</a:t>
                      </a:r>
                      <a:r>
                        <a:rPr lang="en-GB" sz="2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4</a:t>
                      </a:r>
                      <a:endParaRPr lang="en-GB" sz="2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5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40 (0.23 - 0.59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95 (0.94 - 0.96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ressure sores</a:t>
                      </a:r>
                      <a:r>
                        <a:rPr lang="en-GB" sz="2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4</a:t>
                      </a:r>
                      <a:endParaRPr lang="en-GB" sz="2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5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20 (0.09 - 0.39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96 (0.95 - 0.96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kin ulcer</a:t>
                      </a:r>
                      <a:r>
                        <a:rPr lang="en-GB" sz="2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5</a:t>
                      </a:r>
                      <a:endParaRPr lang="en-GB" sz="2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6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84 (0.73 - 0.9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87 (0.86 - 0.88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11360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21</Words>
  <Application>Microsoft Office PowerPoint</Application>
  <PresentationFormat>Widescreen</PresentationFormat>
  <Paragraphs>5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 G</dc:creator>
  <cp:lastModifiedBy>Oghenekome Gibinigie</cp:lastModifiedBy>
  <cp:revision>3</cp:revision>
  <dcterms:created xsi:type="dcterms:W3CDTF">2018-07-28T11:36:00Z</dcterms:created>
  <dcterms:modified xsi:type="dcterms:W3CDTF">2018-09-26T16:42:08Z</dcterms:modified>
</cp:coreProperties>
</file>